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5FBBF1-1E0F-4478-8DF3-00D26DD9F876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2D65FC-42EF-4F44-A5F4-DC3B4CA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5316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2D65FC-42EF-4F44-A5F4-DC3B4CA072A5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66248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8935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2816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8785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7192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2652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6102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5508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0762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9690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6539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9333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D1B0C2-A40D-4E5E-B3DD-BC6D62FB124E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1EDFE-84AD-4616-8A0F-B14CCE427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6100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971" y="324612"/>
            <a:ext cx="3240024" cy="2429256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8274" y="324612"/>
            <a:ext cx="3240024" cy="242925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1005" y="324612"/>
            <a:ext cx="3240024" cy="2429256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5176" y="3509963"/>
            <a:ext cx="3240024" cy="2429256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8274" y="3509963"/>
            <a:ext cx="3240024" cy="2429256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1005" y="3509963"/>
            <a:ext cx="3240024" cy="242925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797056" y="2947249"/>
            <a:ext cx="4353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7d</a:t>
            </a:r>
            <a:r>
              <a:rPr lang="en-US" altLang="zh-CN" dirty="0" smtClean="0"/>
              <a:t>-1O2-NGs, PBS, SCNGs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3557571" y="6139214"/>
            <a:ext cx="42241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7d</a:t>
            </a:r>
            <a:r>
              <a:rPr lang="en-US" altLang="zh-CN" dirty="0" smtClean="0"/>
              <a:t>-HE-NGs, PBS, 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868787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200" y="365125"/>
            <a:ext cx="3240024" cy="2429256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2480" y="365125"/>
            <a:ext cx="3240024" cy="242925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3776" y="365125"/>
            <a:ext cx="3240024" cy="2429256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200" y="3450989"/>
            <a:ext cx="3240024" cy="2429256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2480" y="3450989"/>
            <a:ext cx="3240024" cy="2429256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3776" y="3376520"/>
            <a:ext cx="3240024" cy="242925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797056" y="2947249"/>
            <a:ext cx="44405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7d</a:t>
            </a:r>
            <a:r>
              <a:rPr lang="en-US" altLang="zh-CN" dirty="0" smtClean="0"/>
              <a:t>-</a:t>
            </a:r>
            <a:r>
              <a:rPr lang="en-US" altLang="zh-CN" dirty="0" err="1" smtClean="0"/>
              <a:t>HClO</a:t>
            </a:r>
            <a:r>
              <a:rPr lang="en-US" altLang="zh-CN" dirty="0" smtClean="0"/>
              <a:t>-NGs, PBS, SCNGs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3631593" y="6099752"/>
            <a:ext cx="52179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7d</a:t>
            </a:r>
            <a:r>
              <a:rPr lang="en-US" altLang="zh-CN" dirty="0" smtClean="0"/>
              <a:t>-Prussian blue-NGs, PBS, 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633986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903" y="729115"/>
            <a:ext cx="3240024" cy="2429256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8749" y="729115"/>
            <a:ext cx="3240024" cy="242925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26680" y="729115"/>
            <a:ext cx="3240024" cy="2429256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3370336" y="3652643"/>
            <a:ext cx="4348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7d</a:t>
            </a:r>
            <a:r>
              <a:rPr lang="en-US" altLang="zh-CN" dirty="0" smtClean="0"/>
              <a:t>-ROS-NGs, PBS, 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17938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7</Words>
  <Application>Microsoft Office PowerPoint</Application>
  <PresentationFormat>宽屏</PresentationFormat>
  <Paragraphs>6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霞</dc:creator>
  <cp:lastModifiedBy>王 霞</cp:lastModifiedBy>
  <cp:revision>1</cp:revision>
  <dcterms:created xsi:type="dcterms:W3CDTF">2018-11-11T14:19:16Z</dcterms:created>
  <dcterms:modified xsi:type="dcterms:W3CDTF">2018-11-11T14:22:49Z</dcterms:modified>
</cp:coreProperties>
</file>